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 showGuides="1">
      <p:cViewPr varScale="1">
        <p:scale>
          <a:sx n="62" d="100"/>
          <a:sy n="62" d="100"/>
        </p:scale>
        <p:origin x="2010" y="21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A4D7A-78D3-478A-A708-97B2FEC30B69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8C402-D03E-42A3-BE6C-0644FF2FBF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62351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A4D7A-78D3-478A-A708-97B2FEC30B69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8C402-D03E-42A3-BE6C-0644FF2FBF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70002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A4D7A-78D3-478A-A708-97B2FEC30B69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8C402-D03E-42A3-BE6C-0644FF2FBF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2466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A4D7A-78D3-478A-A708-97B2FEC30B69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8C402-D03E-42A3-BE6C-0644FF2FBF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82252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A4D7A-78D3-478A-A708-97B2FEC30B69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8C402-D03E-42A3-BE6C-0644FF2FBF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72887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A4D7A-78D3-478A-A708-97B2FEC30B69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8C402-D03E-42A3-BE6C-0644FF2FBF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39840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A4D7A-78D3-478A-A708-97B2FEC30B69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8C402-D03E-42A3-BE6C-0644FF2FBF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19601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A4D7A-78D3-478A-A708-97B2FEC30B69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8C402-D03E-42A3-BE6C-0644FF2FBF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31278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A4D7A-78D3-478A-A708-97B2FEC30B69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8C402-D03E-42A3-BE6C-0644FF2FBF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75022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A4D7A-78D3-478A-A708-97B2FEC30B69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8C402-D03E-42A3-BE6C-0644FF2FBF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39593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A4D7A-78D3-478A-A708-97B2FEC30B69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8C402-D03E-42A3-BE6C-0644FF2FBF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25335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6A4D7A-78D3-478A-A708-97B2FEC30B69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D8C402-D03E-42A3-BE6C-0644FF2FBF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99112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18" Type="http://schemas.openxmlformats.org/officeDocument/2006/relationships/image" Target="../media/image16.tiff"/><Relationship Id="rId3" Type="http://schemas.microsoft.com/office/2007/relationships/hdphoto" Target="../media/hdphoto1.wdp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17" Type="http://schemas.openxmlformats.org/officeDocument/2006/relationships/image" Target="../media/image15.tiff"/><Relationship Id="rId2" Type="http://schemas.openxmlformats.org/officeDocument/2006/relationships/image" Target="../media/image1.png"/><Relationship Id="rId16" Type="http://schemas.openxmlformats.org/officeDocument/2006/relationships/image" Target="../media/image14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5" Type="http://schemas.openxmlformats.org/officeDocument/2006/relationships/image" Target="../media/image13.tiff"/><Relationship Id="rId10" Type="http://schemas.openxmlformats.org/officeDocument/2006/relationships/image" Target="../media/image8.tiff"/><Relationship Id="rId19" Type="http://schemas.openxmlformats.org/officeDocument/2006/relationships/image" Target="../media/image17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Relationship Id="rId14" Type="http://schemas.openxmlformats.org/officeDocument/2006/relationships/image" Target="../media/image1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BBB6DC1-3AFB-5235-083C-435B262D4E9B}"/>
              </a:ext>
            </a:extLst>
          </p:cNvPr>
          <p:cNvSpPr txBox="1"/>
          <p:nvPr/>
        </p:nvSpPr>
        <p:spPr>
          <a:xfrm>
            <a:off x="368300" y="330200"/>
            <a:ext cx="21044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 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E37D050-87BF-C785-BB66-317A1A4E6E66}"/>
              </a:ext>
            </a:extLst>
          </p:cNvPr>
          <p:cNvSpPr txBox="1"/>
          <p:nvPr/>
        </p:nvSpPr>
        <p:spPr>
          <a:xfrm>
            <a:off x="1722508" y="816527"/>
            <a:ext cx="7328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0B39132-0791-782F-7145-56E154035DAC}"/>
              </a:ext>
            </a:extLst>
          </p:cNvPr>
          <p:cNvSpPr txBox="1"/>
          <p:nvPr/>
        </p:nvSpPr>
        <p:spPr>
          <a:xfrm>
            <a:off x="3180479" y="843495"/>
            <a:ext cx="10690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PAF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CC9D8C60-1A86-D7FA-EA22-FC84236EEAA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7834" y="1078979"/>
            <a:ext cx="1202400" cy="1202400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CEE2B861-1672-9535-3B36-9C4BE4D3254A}"/>
              </a:ext>
            </a:extLst>
          </p:cNvPr>
          <p:cNvSpPr txBox="1"/>
          <p:nvPr/>
        </p:nvSpPr>
        <p:spPr>
          <a:xfrm rot="16200000">
            <a:off x="1084420" y="1453725"/>
            <a:ext cx="591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O-1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1579F44-910D-28B3-4EF4-1394056F8D55}"/>
              </a:ext>
            </a:extLst>
          </p:cNvPr>
          <p:cNvSpPr txBox="1"/>
          <p:nvPr/>
        </p:nvSpPr>
        <p:spPr>
          <a:xfrm rot="16200000">
            <a:off x="1094038" y="2784973"/>
            <a:ext cx="5725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err="1">
                <a:solidFill>
                  <a:srgbClr val="3333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n-GB" sz="1400" b="1">
              <a:solidFill>
                <a:srgbClr val="3333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Picture 30">
            <a:extLst>
              <a:ext uri="{FF2B5EF4-FFF2-40B4-BE49-F238E27FC236}">
                <a16:creationId xmlns:a16="http://schemas.microsoft.com/office/drawing/2014/main" id="{AAD23B97-7F64-2659-0988-080FDCB0181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6222" y="3664360"/>
            <a:ext cx="1202400" cy="1202400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E81EA711-7E67-42F2-1150-4B19CE89A30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7786" y="3664360"/>
            <a:ext cx="1202400" cy="1202400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710BB9B8-879B-355E-6689-E8D71E76F52E}"/>
              </a:ext>
            </a:extLst>
          </p:cNvPr>
          <p:cNvSpPr txBox="1"/>
          <p:nvPr/>
        </p:nvSpPr>
        <p:spPr>
          <a:xfrm rot="16200000">
            <a:off x="895454" y="4116628"/>
            <a:ext cx="9989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audin-1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DFA748C-00D0-DD2D-8FAB-74D7A1AFBE30}"/>
              </a:ext>
            </a:extLst>
          </p:cNvPr>
          <p:cNvSpPr txBox="1"/>
          <p:nvPr/>
        </p:nvSpPr>
        <p:spPr>
          <a:xfrm rot="16200000">
            <a:off x="1108652" y="5410298"/>
            <a:ext cx="5725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err="1">
                <a:solidFill>
                  <a:srgbClr val="3333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n-GB" sz="1400" b="1">
              <a:solidFill>
                <a:srgbClr val="3333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ABA5FAD1-E06E-9FA5-8470-2C1A6257BA9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62931" y="3664360"/>
            <a:ext cx="1202400" cy="1202400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3EE96DA0-C4FB-BCAB-DB00-A1BDF0B00DB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9686" y="6318292"/>
            <a:ext cx="1202400" cy="1202400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4CEA3418-320F-E55F-76C7-959F455719B5}"/>
              </a:ext>
            </a:extLst>
          </p:cNvPr>
          <p:cNvSpPr txBox="1"/>
          <p:nvPr/>
        </p:nvSpPr>
        <p:spPr>
          <a:xfrm rot="16200000">
            <a:off x="828958" y="6776474"/>
            <a:ext cx="11095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-cadherin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04FFB992-E822-B412-B4A8-C63B06E2ECBE}"/>
              </a:ext>
            </a:extLst>
          </p:cNvPr>
          <p:cNvSpPr txBox="1"/>
          <p:nvPr/>
        </p:nvSpPr>
        <p:spPr>
          <a:xfrm rot="16200000">
            <a:off x="1097461" y="8082670"/>
            <a:ext cx="5725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err="1">
                <a:solidFill>
                  <a:srgbClr val="3333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n-GB" sz="1400" b="1">
              <a:solidFill>
                <a:srgbClr val="3333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9" name="Picture 48">
            <a:extLst>
              <a:ext uri="{FF2B5EF4-FFF2-40B4-BE49-F238E27FC236}">
                <a16:creationId xmlns:a16="http://schemas.microsoft.com/office/drawing/2014/main" id="{20E40F15-A41C-A3BB-A934-F0BD8C459F7D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8753" y="6318292"/>
            <a:ext cx="1202400" cy="1202400"/>
          </a:xfrm>
          <a:prstGeom prst="rect">
            <a:avLst/>
          </a:prstGeom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A6D9E239-C026-0AEA-E06E-F4963ABC9CDD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72821" y="6330184"/>
            <a:ext cx="1202400" cy="1202400"/>
          </a:xfrm>
          <a:prstGeom prst="rect">
            <a:avLst/>
          </a:prstGeom>
        </p:spPr>
      </p:pic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7C40A1BE-ECE6-1C9F-73EF-918B05FAB801}"/>
              </a:ext>
            </a:extLst>
          </p:cNvPr>
          <p:cNvCxnSpPr>
            <a:cxnSpLocks/>
          </p:cNvCxnSpPr>
          <p:nvPr/>
        </p:nvCxnSpPr>
        <p:spPr>
          <a:xfrm>
            <a:off x="2548879" y="4737134"/>
            <a:ext cx="114753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0D30C50A-80A8-8F46-39AF-BDEA0B91B2AA}"/>
              </a:ext>
            </a:extLst>
          </p:cNvPr>
          <p:cNvCxnSpPr>
            <a:cxnSpLocks/>
          </p:cNvCxnSpPr>
          <p:nvPr/>
        </p:nvCxnSpPr>
        <p:spPr>
          <a:xfrm>
            <a:off x="2560607" y="2168008"/>
            <a:ext cx="114753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EBA0DB87-22AF-B3FE-91B3-2BAF4E85EF77}"/>
              </a:ext>
            </a:extLst>
          </p:cNvPr>
          <p:cNvCxnSpPr>
            <a:cxnSpLocks/>
          </p:cNvCxnSpPr>
          <p:nvPr/>
        </p:nvCxnSpPr>
        <p:spPr>
          <a:xfrm>
            <a:off x="2535608" y="7399484"/>
            <a:ext cx="114753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Picture 6">
            <a:extLst>
              <a:ext uri="{FF2B5EF4-FFF2-40B4-BE49-F238E27FC236}">
                <a16:creationId xmlns:a16="http://schemas.microsoft.com/office/drawing/2014/main" id="{9FD50624-A767-AD08-2758-2AC64366A5B9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4223" y="2383755"/>
            <a:ext cx="1202400" cy="12024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578A841C-1AA1-D283-0CAC-B4F588EE73CF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65378" y="2377958"/>
            <a:ext cx="1202400" cy="12024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B2D265C2-0975-9F60-83CD-8CB2E239A25E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62412" y="2375927"/>
            <a:ext cx="1202400" cy="120240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6C9297AD-8463-4AD8-5EE4-9C806904E10E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6222" y="5022537"/>
            <a:ext cx="1202400" cy="120240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467523FE-C781-3CBD-985D-113A6D00999A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7786" y="5022537"/>
            <a:ext cx="1202400" cy="1202400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E5CB6984-3F32-966F-5C0C-E87662DE9962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9446" y="5022537"/>
            <a:ext cx="1202400" cy="1202400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6075DA9B-02E0-6338-466D-EEAA74A2263A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9597" y="7635358"/>
            <a:ext cx="1202400" cy="1202400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B28CDF43-C627-65A2-5842-301D3A1A12D7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1161" y="7635358"/>
            <a:ext cx="1202400" cy="1202400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426FFFB0-1933-CFC6-F1F1-CD3DCE0A4330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72821" y="7644646"/>
            <a:ext cx="1202400" cy="12024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996CD311-88FB-94A8-20CD-CABAEE56C189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65747" y="1078979"/>
            <a:ext cx="1202400" cy="12024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A39F0A1-082A-5C61-5D69-BDB7FC511B85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4223" y="1084607"/>
            <a:ext cx="1202400" cy="1202400"/>
          </a:xfrm>
          <a:prstGeom prst="rect">
            <a:avLst/>
          </a:prstGeom>
        </p:spPr>
      </p:pic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01E12E47-11CA-64A1-BF97-5907AA747E07}"/>
              </a:ext>
            </a:extLst>
          </p:cNvPr>
          <p:cNvCxnSpPr>
            <a:cxnSpLocks/>
          </p:cNvCxnSpPr>
          <p:nvPr/>
        </p:nvCxnSpPr>
        <p:spPr>
          <a:xfrm>
            <a:off x="2548135" y="2179046"/>
            <a:ext cx="114753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3CE4E885-CC6E-BD5D-CC1D-298BAB92BC81}"/>
              </a:ext>
            </a:extLst>
          </p:cNvPr>
          <p:cNvSpPr txBox="1"/>
          <p:nvPr/>
        </p:nvSpPr>
        <p:spPr>
          <a:xfrm>
            <a:off x="680605" y="8847046"/>
            <a:ext cx="5496790" cy="106182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just"/>
            <a:r>
              <a:rPr lang="en-GB" sz="1050" b="1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Figure S3. BML-111 restores PAF-reduced ZO-1.</a:t>
            </a:r>
            <a:r>
              <a:rPr lang="en-GB" sz="1050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  Images of 16HBE14o- cells treated with </a:t>
            </a:r>
            <a:r>
              <a:rPr lang="en-GB" sz="1050" i="1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Pseudomonas aeruginosa</a:t>
            </a:r>
            <a:r>
              <a:rPr lang="en-GB" sz="1050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 filtrate (PAF) or PAF + </a:t>
            </a:r>
            <a:r>
              <a:rPr lang="en-GB" sz="105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200 nmol/L </a:t>
            </a:r>
            <a:r>
              <a:rPr lang="en-GB" sz="1050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BML-111 and </a:t>
            </a:r>
            <a:r>
              <a:rPr lang="en-GB" sz="1050" dirty="0" err="1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immunostained</a:t>
            </a:r>
            <a:r>
              <a:rPr lang="en-GB" sz="1050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 for ZO-1  or Claudin-1 or E-cadherin (red) with corresponding images of nuclei stained with </a:t>
            </a:r>
            <a:r>
              <a:rPr lang="en-GB" sz="1050" dirty="0" err="1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Dapi</a:t>
            </a:r>
            <a:r>
              <a:rPr lang="en-GB" sz="1050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 (blue). All images were obtained at ×63 magnification. Scale bars (20 </a:t>
            </a:r>
            <a:r>
              <a:rPr lang="en-GB" sz="1050" dirty="0" err="1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μm</a:t>
            </a:r>
            <a:r>
              <a:rPr lang="en-GB" sz="1050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) are shown on control images only but are applicable to all.</a:t>
            </a:r>
          </a:p>
          <a:p>
            <a:pPr algn="just"/>
            <a:endParaRPr lang="en-GB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91D9DA3-2D26-3566-8DD0-0C0147EEE3F0}"/>
              </a:ext>
            </a:extLst>
          </p:cNvPr>
          <p:cNvSpPr txBox="1"/>
          <p:nvPr/>
        </p:nvSpPr>
        <p:spPr>
          <a:xfrm>
            <a:off x="3862046" y="666891"/>
            <a:ext cx="16864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200 nmol/L BML-111 + PAF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17914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95</Words>
  <Application>Microsoft Office PowerPoint</Application>
  <PresentationFormat>A4 Paper (210x297 mm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meljit Kalsi</dc:creator>
  <cp:lastModifiedBy>Kameljit Kalsi</cp:lastModifiedBy>
  <cp:revision>2</cp:revision>
  <dcterms:created xsi:type="dcterms:W3CDTF">2022-06-02T11:18:06Z</dcterms:created>
  <dcterms:modified xsi:type="dcterms:W3CDTF">2023-03-30T15:21:30Z</dcterms:modified>
</cp:coreProperties>
</file>